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756"/>
    <p:restoredTop sz="95952"/>
  </p:normalViewPr>
  <p:slideViewPr>
    <p:cSldViewPr snapToGrid="0" snapToObjects="1">
      <p:cViewPr varScale="1">
        <p:scale>
          <a:sx n="110" d="100"/>
          <a:sy n="110" d="100"/>
        </p:scale>
        <p:origin x="1344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C1FEB-3130-5547-8C5F-33B04F7EFC72}" type="datetimeFigureOut">
              <a:rPr kumimoji="1" lang="ja-JP" altLang="en-US" smtClean="0"/>
              <a:t>2022/1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74835-6624-0447-A176-9D08CCFA4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06177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C1FEB-3130-5547-8C5F-33B04F7EFC72}" type="datetimeFigureOut">
              <a:rPr kumimoji="1" lang="ja-JP" altLang="en-US" smtClean="0"/>
              <a:t>2022/1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74835-6624-0447-A176-9D08CCFA4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11553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C1FEB-3130-5547-8C5F-33B04F7EFC72}" type="datetimeFigureOut">
              <a:rPr kumimoji="1" lang="ja-JP" altLang="en-US" smtClean="0"/>
              <a:t>2022/1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74835-6624-0447-A176-9D08CCFA4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37972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C1FEB-3130-5547-8C5F-33B04F7EFC72}" type="datetimeFigureOut">
              <a:rPr kumimoji="1" lang="ja-JP" altLang="en-US" smtClean="0"/>
              <a:t>2022/1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74835-6624-0447-A176-9D08CCFA4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61775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C1FEB-3130-5547-8C5F-33B04F7EFC72}" type="datetimeFigureOut">
              <a:rPr kumimoji="1" lang="ja-JP" altLang="en-US" smtClean="0"/>
              <a:t>2022/1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74835-6624-0447-A176-9D08CCFA4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22478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C1FEB-3130-5547-8C5F-33B04F7EFC72}" type="datetimeFigureOut">
              <a:rPr kumimoji="1" lang="ja-JP" altLang="en-US" smtClean="0"/>
              <a:t>2022/1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74835-6624-0447-A176-9D08CCFA4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9502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C1FEB-3130-5547-8C5F-33B04F7EFC72}" type="datetimeFigureOut">
              <a:rPr kumimoji="1" lang="ja-JP" altLang="en-US" smtClean="0"/>
              <a:t>2022/1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74835-6624-0447-A176-9D08CCFA4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81822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C1FEB-3130-5547-8C5F-33B04F7EFC72}" type="datetimeFigureOut">
              <a:rPr kumimoji="1" lang="ja-JP" altLang="en-US" smtClean="0"/>
              <a:t>2022/1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74835-6624-0447-A176-9D08CCFA4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73976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C1FEB-3130-5547-8C5F-33B04F7EFC72}" type="datetimeFigureOut">
              <a:rPr kumimoji="1" lang="ja-JP" altLang="en-US" smtClean="0"/>
              <a:t>2022/1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74835-6624-0447-A176-9D08CCFA4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9382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C1FEB-3130-5547-8C5F-33B04F7EFC72}" type="datetimeFigureOut">
              <a:rPr kumimoji="1" lang="ja-JP" altLang="en-US" smtClean="0"/>
              <a:t>2022/1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74835-6624-0447-A176-9D08CCFA4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81522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C1FEB-3130-5547-8C5F-33B04F7EFC72}" type="datetimeFigureOut">
              <a:rPr kumimoji="1" lang="ja-JP" altLang="en-US" smtClean="0"/>
              <a:t>2022/1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374835-6624-0447-A176-9D08CCFA4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35535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3C1FEB-3130-5547-8C5F-33B04F7EFC72}" type="datetimeFigureOut">
              <a:rPr kumimoji="1" lang="ja-JP" altLang="en-US" smtClean="0"/>
              <a:t>2022/1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374835-6624-0447-A176-9D08CCFA4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35016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3A33BD60-64F7-7343-87F3-73986D1716B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06523" y="359217"/>
            <a:ext cx="7493000" cy="4889500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EA71335A-B5D6-2744-9BB6-580DC776FC4E}"/>
              </a:ext>
            </a:extLst>
          </p:cNvPr>
          <p:cNvSpPr txBox="1"/>
          <p:nvPr/>
        </p:nvSpPr>
        <p:spPr>
          <a:xfrm>
            <a:off x="3905532" y="5234621"/>
            <a:ext cx="152811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Time (days)</a:t>
            </a:r>
            <a:endParaRPr kumimoji="1" lang="ja-JP" altLang="en-US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DA27877A-7CF6-9146-AF3F-7B3B7D813F7C}"/>
              </a:ext>
            </a:extLst>
          </p:cNvPr>
          <p:cNvSpPr/>
          <p:nvPr/>
        </p:nvSpPr>
        <p:spPr>
          <a:xfrm>
            <a:off x="315541" y="5213830"/>
            <a:ext cx="145367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" altLang="ja-JP" dirty="0"/>
              <a:t>October 15th, 2018 </a:t>
            </a:r>
            <a:endParaRPr lang="ja-JP" altLang="en-US"/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35561DAB-1322-4B43-AD72-CDC08EC44212}"/>
              </a:ext>
            </a:extLst>
          </p:cNvPr>
          <p:cNvSpPr/>
          <p:nvPr/>
        </p:nvSpPr>
        <p:spPr>
          <a:xfrm>
            <a:off x="7028323" y="5257265"/>
            <a:ext cx="135367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" altLang="ja-JP" dirty="0"/>
              <a:t>March 9th, 2019</a:t>
            </a:r>
            <a:endParaRPr lang="ja-JP" altLang="en-US"/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BE9A0CA5-706B-EA43-8017-8B059D3CDEB1}"/>
              </a:ext>
            </a:extLst>
          </p:cNvPr>
          <p:cNvSpPr/>
          <p:nvPr/>
        </p:nvSpPr>
        <p:spPr>
          <a:xfrm>
            <a:off x="733174" y="5992321"/>
            <a:ext cx="787282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977900" indent="-977900"/>
            <a:r>
              <a:rPr lang="en-US" altLang="ja-JP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 S1:</a:t>
            </a:r>
            <a:r>
              <a:rPr lang="en-US" altLang="ja-JP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Water temperature during the experimental period (from October 15th, 2018 to March 9th, 2019) </a:t>
            </a:r>
            <a:endParaRPr lang="ja-JP" altLang="en-US">
              <a:highlight>
                <a:srgbClr val="FFFF00"/>
              </a:highligh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A2A36BD9-40ED-3D48-81BD-E213B7D0F838}"/>
              </a:ext>
            </a:extLst>
          </p:cNvPr>
          <p:cNvSpPr txBox="1"/>
          <p:nvPr/>
        </p:nvSpPr>
        <p:spPr>
          <a:xfrm rot="16200000">
            <a:off x="-916976" y="2530676"/>
            <a:ext cx="297081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Water temperature ( </a:t>
            </a:r>
            <a:r>
              <a:rPr kumimoji="1" lang="en-US" altLang="ja-JP" sz="20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kumimoji="1" lang="en-US" altLang="ja-JP" sz="2000" dirty="0" err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 )</a:t>
            </a:r>
            <a:endParaRPr kumimoji="1" lang="ja-JP" altLang="en-US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804018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00</TotalTime>
  <Words>38</Words>
  <Application>Microsoft Macintosh PowerPoint</Application>
  <PresentationFormat>画面に合わせる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宮坂 研究室</dc:creator>
  <cp:lastModifiedBy>宮坂 研究室</cp:lastModifiedBy>
  <cp:revision>10</cp:revision>
  <dcterms:created xsi:type="dcterms:W3CDTF">2021-11-27T09:41:34Z</dcterms:created>
  <dcterms:modified xsi:type="dcterms:W3CDTF">2022-01-16T02:22:15Z</dcterms:modified>
</cp:coreProperties>
</file>